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3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6014" autoAdjust="0"/>
    <p:restoredTop sz="94660"/>
  </p:normalViewPr>
  <p:slideViewPr>
    <p:cSldViewPr snapToGrid="0">
      <p:cViewPr varScale="1">
        <p:scale>
          <a:sx n="159" d="100"/>
          <a:sy n="159" d="100"/>
        </p:scale>
        <p:origin x="306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C66ED-3E96-DB89-149C-40B3643D0DB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73277A-6BB4-DA92-4393-243EEEA62D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8BC621-894E-D55C-8A8E-8D85B4A07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CBAC36-94F9-BC71-FF31-F7AE66137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2B6CC0-7D68-8B72-D9AC-85F29657C6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0987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D9F04-1032-FE6F-FAC1-04A84F427A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00ADEE-A9D1-9CA9-9C29-CA8BC168BB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391608-50E2-C1DD-270B-8545C312D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662944-4F17-3084-150A-0C99A797E9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50160E-7CCE-63D0-EF94-F82F6AE81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8913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B4FCE4-0E9D-F4C8-1878-DC22DAD9204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18ABB05-BFFB-F50F-88EB-1FD22C5106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CADD33-1EE5-D6D5-2C67-A6FD4D828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16752D-539C-9751-B92C-7FBF821D45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7F89A1-FDF7-D84C-0492-70D92896C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9895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FF1E30-5D82-EF8C-3DC3-55A86C88F8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D37F6C-72C4-3995-C506-0949268E81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49A4E2-C74A-53A6-57E1-987661892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C1FA33-2050-994F-87F0-F6365032E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CA594B-0246-3C41-6E41-1046F5AA1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5005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8995D6-0511-4E1C-2C46-268804437E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DEC88A9-3506-FF6C-2A2B-D2E1A390ED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697F68-2679-2F12-E017-2414D2EAE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4B4FC4-EC25-EF02-8281-049198ED0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60B64-B9F1-4ACE-8DF8-D2B23BF4B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9417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F88DA-C542-0E29-F6E6-59E6F87657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6FA010-08AD-73F4-845F-EC77A55F24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699E70-FE03-3B53-AF76-473DD0D91E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180134-A2AC-7634-E335-70830E6D1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90E032-69A6-53AB-7111-7F86DA6ADD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E25805-8F9A-61A0-4C2F-E97A003F74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2640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809A6-0D8A-B19B-8DDB-789D15335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34441D-DD83-7E18-1331-8DA6BB24D9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3B1168-28FC-AFD2-5363-7BB8E36BE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4BD87C-B46D-0E8E-6735-73D6CC37C1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CFF96A-36F8-C58E-3518-CF499F6D2D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E1C8C73-527D-C821-7B60-C076C7BF3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1D1D96-F50A-E63C-3B8C-A2BB3F378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6710FF7-560E-F40D-28C2-AA17E0BF91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0573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8428F3-A2B2-71AB-4893-F69C9FD7BB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7EF350-38F2-BDD5-670F-222575B48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88EC1D5-521C-11D6-B030-8295B5C57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394044-DF95-7242-A499-876471D34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8322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BBB2F5-1197-235C-AC85-E6476FEB8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8BB261-B7E6-6707-7898-74A69D83A4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9FF6BC-C208-44F1-5B46-96EFAAC57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00041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0BA0C-08D6-505D-7A8B-2B5E2899B3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7D94E7-295A-9D5F-9525-0E28EECE54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F0F1B1-A968-E912-8CFA-8AAF399148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E60404-C6DE-7C96-2118-6B8A70175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8EBE1C-2452-26C0-F49F-86B5EB49A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8794EE-61BA-59EA-4D23-55B94383A5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3496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B364E8-98E9-B3D4-2A5C-54A6441E6C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D58428-18EE-C34C-8D8A-CD92888AD5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2887A7-725E-716D-3DE0-A2AAA942A8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F73DD2-8671-1C26-5D06-13049E36AB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DE8D71-11AB-2EC6-0DBF-02840011C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48FF71-4A22-1A30-82B3-ED371A5F5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1540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07B2622-31F6-B8A5-00C3-259D748546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0410D4-9E12-500A-4ABD-1381729EA8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3ECB4B-748A-CAC3-5247-9586D19B5E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F3AEC4-7E2A-49A6-BE51-2B2468F89582}" type="datetimeFigureOut">
              <a:rPr lang="fr-FR" smtClean="0"/>
              <a:t>22/01/2023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5D7C47-AFAA-8F75-51C7-D278BC50DA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2C008-B63F-57DC-D981-A0BAA67D1D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07805C-8310-4C0D-9591-DB027A857DD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01683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r="2768"/>
          <a:stretch/>
        </p:blipFill>
        <p:spPr>
          <a:xfrm>
            <a:off x="28423" y="153839"/>
            <a:ext cx="12145712" cy="570703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47088" y="2785576"/>
            <a:ext cx="4126865" cy="114420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43658" y="396865"/>
            <a:ext cx="4126864" cy="115682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16618D4-54E6-C3C3-9368-8036198EA0B9}"/>
              </a:ext>
            </a:extLst>
          </p:cNvPr>
          <p:cNvSpPr txBox="1"/>
          <p:nvPr/>
        </p:nvSpPr>
        <p:spPr>
          <a:xfrm>
            <a:off x="-5714" y="-53788"/>
            <a:ext cx="250498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Hippocampus Electrodes</a:t>
            </a:r>
            <a:endParaRPr lang="fr-FR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CDC58CC-F00E-FCA9-CCC3-00E4B73AB28D}"/>
              </a:ext>
            </a:extLst>
          </p:cNvPr>
          <p:cNvSpPr txBox="1"/>
          <p:nvPr/>
        </p:nvSpPr>
        <p:spPr>
          <a:xfrm>
            <a:off x="-13062" y="343033"/>
            <a:ext cx="418704" cy="426270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spcBef>
                <a:spcPts val="600"/>
              </a:spcBef>
            </a:pPr>
            <a:r>
              <a:rPr lang="en-US" dirty="0"/>
              <a:t>1</a:t>
            </a:r>
          </a:p>
          <a:p>
            <a:pPr>
              <a:spcBef>
                <a:spcPts val="600"/>
              </a:spcBef>
            </a:pPr>
            <a:r>
              <a:rPr lang="en-US" dirty="0"/>
              <a:t>2</a:t>
            </a:r>
          </a:p>
          <a:p>
            <a:pPr>
              <a:spcBef>
                <a:spcPts val="600"/>
              </a:spcBef>
            </a:pPr>
            <a:r>
              <a:rPr lang="en-US" dirty="0"/>
              <a:t>3</a:t>
            </a:r>
          </a:p>
          <a:p>
            <a:pPr>
              <a:spcBef>
                <a:spcPts val="600"/>
              </a:spcBef>
            </a:pPr>
            <a:r>
              <a:rPr lang="en-US" dirty="0"/>
              <a:t>4</a:t>
            </a:r>
          </a:p>
          <a:p>
            <a:pPr>
              <a:spcBef>
                <a:spcPts val="600"/>
              </a:spcBef>
            </a:pPr>
            <a:r>
              <a:rPr lang="en-US" dirty="0"/>
              <a:t>5</a:t>
            </a:r>
          </a:p>
          <a:p>
            <a:pPr>
              <a:spcBef>
                <a:spcPts val="600"/>
              </a:spcBef>
            </a:pPr>
            <a:r>
              <a:rPr lang="en-US" dirty="0"/>
              <a:t>6</a:t>
            </a:r>
          </a:p>
          <a:p>
            <a:pPr>
              <a:spcBef>
                <a:spcPts val="600"/>
              </a:spcBef>
            </a:pPr>
            <a:r>
              <a:rPr lang="en-US" dirty="0"/>
              <a:t>7</a:t>
            </a:r>
          </a:p>
          <a:p>
            <a:pPr>
              <a:spcBef>
                <a:spcPts val="600"/>
              </a:spcBef>
            </a:pPr>
            <a:r>
              <a:rPr lang="en-US" dirty="0"/>
              <a:t>8</a:t>
            </a:r>
          </a:p>
          <a:p>
            <a:pPr>
              <a:spcBef>
                <a:spcPts val="600"/>
              </a:spcBef>
            </a:pPr>
            <a:r>
              <a:rPr lang="en-US" dirty="0"/>
              <a:t>9</a:t>
            </a:r>
          </a:p>
          <a:p>
            <a:pPr>
              <a:spcBef>
                <a:spcPts val="600"/>
              </a:spcBef>
            </a:pPr>
            <a:r>
              <a:rPr lang="en-US" dirty="0"/>
              <a:t>10</a:t>
            </a:r>
          </a:p>
          <a:p>
            <a:pPr>
              <a:spcBef>
                <a:spcPts val="600"/>
              </a:spcBef>
            </a:pPr>
            <a:r>
              <a:rPr lang="en-US" dirty="0"/>
              <a:t>11</a:t>
            </a:r>
          </a:p>
          <a:p>
            <a:pPr>
              <a:spcBef>
                <a:spcPts val="600"/>
              </a:spcBef>
            </a:pPr>
            <a:r>
              <a:rPr lang="en-US" dirty="0"/>
              <a:t>12</a:t>
            </a:r>
            <a:endParaRPr lang="fr-FR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001567-5D8A-BCD9-B49F-8B7CF3521BC4}"/>
              </a:ext>
            </a:extLst>
          </p:cNvPr>
          <p:cNvSpPr txBox="1"/>
          <p:nvPr/>
        </p:nvSpPr>
        <p:spPr>
          <a:xfrm>
            <a:off x="-5714" y="4556225"/>
            <a:ext cx="2646943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Medial Septum Electrodes</a:t>
            </a:r>
            <a:endParaRPr lang="fr-FR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AA8ECA5-B073-E3C4-C7E1-F50E655110EE}"/>
              </a:ext>
            </a:extLst>
          </p:cNvPr>
          <p:cNvSpPr txBox="1"/>
          <p:nvPr/>
        </p:nvSpPr>
        <p:spPr>
          <a:xfrm>
            <a:off x="28423" y="4946756"/>
            <a:ext cx="301686" cy="7232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spcBef>
                <a:spcPts val="600"/>
              </a:spcBef>
            </a:pPr>
            <a:r>
              <a:rPr lang="en-US" dirty="0"/>
              <a:t>1</a:t>
            </a:r>
          </a:p>
          <a:p>
            <a:pPr>
              <a:spcBef>
                <a:spcPts val="600"/>
              </a:spcBef>
            </a:pPr>
            <a:r>
              <a:rPr lang="en-US" dirty="0"/>
              <a:t>2</a:t>
            </a:r>
            <a:endParaRPr lang="fr-FR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274B945-B5EE-16A5-792F-67A60D3AEFB9}"/>
              </a:ext>
            </a:extLst>
          </p:cNvPr>
          <p:cNvSpPr txBox="1"/>
          <p:nvPr/>
        </p:nvSpPr>
        <p:spPr>
          <a:xfrm>
            <a:off x="8412638" y="311090"/>
            <a:ext cx="2438488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ippocampal electrodes 2-4  coherence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250F817-9799-D1B0-DC16-438BC3450C49}"/>
              </a:ext>
            </a:extLst>
          </p:cNvPr>
          <p:cNvSpPr txBox="1"/>
          <p:nvPr/>
        </p:nvSpPr>
        <p:spPr>
          <a:xfrm>
            <a:off x="8434323" y="2680254"/>
            <a:ext cx="2403222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ippocampal electrodes 7-2 coherence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CDA3CDB-2651-6972-6F8A-A76A8FFD82DC}"/>
              </a:ext>
            </a:extLst>
          </p:cNvPr>
          <p:cNvSpPr txBox="1"/>
          <p:nvPr/>
        </p:nvSpPr>
        <p:spPr>
          <a:xfrm>
            <a:off x="320946" y="2069301"/>
            <a:ext cx="31130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X</a:t>
            </a:r>
            <a:endParaRPr lang="fr-FR" b="1" dirty="0">
              <a:solidFill>
                <a:srgbClr val="7030A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27DC702-B4A3-42B6-6AD9-6140E4A43142}"/>
              </a:ext>
            </a:extLst>
          </p:cNvPr>
          <p:cNvSpPr txBox="1"/>
          <p:nvPr/>
        </p:nvSpPr>
        <p:spPr>
          <a:xfrm>
            <a:off x="308510" y="2427929"/>
            <a:ext cx="31130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</a:rPr>
              <a:t>X</a:t>
            </a:r>
            <a:endParaRPr lang="fr-FR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42BB631-CE45-D2B8-4B23-A6BACE9F256A}"/>
              </a:ext>
            </a:extLst>
          </p:cNvPr>
          <p:cNvSpPr txBox="1"/>
          <p:nvPr/>
        </p:nvSpPr>
        <p:spPr>
          <a:xfrm>
            <a:off x="318108" y="4227226"/>
            <a:ext cx="31130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X</a:t>
            </a:r>
            <a:endParaRPr lang="fr-FR" b="1" dirty="0">
              <a:solidFill>
                <a:srgbClr val="7030A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A6E833F-F97A-ACD4-AB61-B6CE6EEDFDCB}"/>
              </a:ext>
            </a:extLst>
          </p:cNvPr>
          <p:cNvSpPr txBox="1"/>
          <p:nvPr/>
        </p:nvSpPr>
        <p:spPr>
          <a:xfrm>
            <a:off x="342599" y="1769801"/>
            <a:ext cx="31130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7030A0"/>
                </a:solidFill>
              </a:rPr>
              <a:t>X</a:t>
            </a:r>
            <a:endParaRPr lang="fr-FR" b="1" dirty="0">
              <a:solidFill>
                <a:srgbClr val="7030A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04D10EF-69EF-F804-BE82-EC686CC106F8}"/>
              </a:ext>
            </a:extLst>
          </p:cNvPr>
          <p:cNvSpPr txBox="1"/>
          <p:nvPr/>
        </p:nvSpPr>
        <p:spPr>
          <a:xfrm>
            <a:off x="53732" y="4925557"/>
            <a:ext cx="301686" cy="7232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>
              <a:spcBef>
                <a:spcPts val="600"/>
              </a:spcBef>
            </a:pPr>
            <a:r>
              <a:rPr lang="en-US" dirty="0"/>
              <a:t>1</a:t>
            </a:r>
          </a:p>
          <a:p>
            <a:pPr>
              <a:spcBef>
                <a:spcPts val="600"/>
              </a:spcBef>
            </a:pPr>
            <a:r>
              <a:rPr lang="en-US" dirty="0"/>
              <a:t>2</a:t>
            </a:r>
            <a:endParaRPr lang="fr-FR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45310FB-7005-B8B8-5D99-C6008B2BA80B}"/>
              </a:ext>
            </a:extLst>
          </p:cNvPr>
          <p:cNvSpPr txBox="1"/>
          <p:nvPr/>
        </p:nvSpPr>
        <p:spPr>
          <a:xfrm>
            <a:off x="105574" y="5968651"/>
            <a:ext cx="1685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. Fig. 1A </a:t>
            </a:r>
          </a:p>
        </p:txBody>
      </p:sp>
    </p:spTree>
    <p:extLst>
      <p:ext uri="{BB962C8B-B14F-4D97-AF65-F5344CB8AC3E}">
        <p14:creationId xmlns:p14="http://schemas.microsoft.com/office/powerpoint/2010/main" val="34957088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8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lmes, Gregory L</dc:creator>
  <cp:lastModifiedBy>Holmes, Gregory L</cp:lastModifiedBy>
  <cp:revision>1</cp:revision>
  <dcterms:created xsi:type="dcterms:W3CDTF">2023-01-22T02:50:58Z</dcterms:created>
  <dcterms:modified xsi:type="dcterms:W3CDTF">2023-01-23T01:56:16Z</dcterms:modified>
</cp:coreProperties>
</file>